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4.xml" ContentType="application/vnd.openxmlformats-officedocument.presentationml.slide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27.xml.rels" ContentType="application/vnd.openxmlformats-package.relationships+xml"/>
  <Override PartName="/ppt/slides/_rels/slide8.xml.rels" ContentType="application/vnd.openxmlformats-package.relationships+xml"/>
  <Override PartName="/ppt/slides/_rels/slide21.xml.rels" ContentType="application/vnd.openxmlformats-package.relationships+xml"/>
  <Override PartName="/ppt/slides/_rels/slide2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7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7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9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14.xml.rels" ContentType="application/vnd.openxmlformats-package.relationships+xml"/>
  <Override PartName="/ppt/slides/_rels/slide23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28.xml.rels" ContentType="application/vnd.openxmlformats-package.relationships+xml"/>
  <Override PartName="/ppt/slides/_rels/slide9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slide30.xml" ContentType="application/vnd.openxmlformats-officedocument.presentationml.slide+xml"/>
  <Override PartName="/ppt/slides/slide28.xml" ContentType="application/vnd.openxmlformats-officedocument.presentationml.slide+xml"/>
  <Override PartName="/ppt/slides/slide1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0.xml" ContentType="application/vnd.openxmlformats-officedocument.presentationml.slide+xml"/>
  <Override PartName="/ppt/slides/slide19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5E521-BA86-4E46-ABAD-E707D37C18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2C84D-8870-45FD-A12C-EAB0953A3B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ABF52-6C9A-4B8F-9B9D-84A73746A7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BD7FC-6303-487A-824A-C0D9247AD4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93E1D-D81C-4EAA-A492-DC20CC009E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39988-ACA0-4E3D-977D-E43026AD5D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7E941-1B1F-4F86-A55B-2AB74436DB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08943-9C57-4BC8-9374-BBF0FC1C41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C627D-6931-45E6-8F10-E779B984AF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560F4-B1B1-41EA-994D-3076E16C83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5E149-D9D3-4B55-A1E5-761AB81296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7DEE1-7F23-4848-BD6E-E52F1B8234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1375F8-E617-4637-A5DE-599F0FB9AA6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803160" y="274680"/>
            <a:ext cx="753588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1190520" y="681120"/>
            <a:ext cx="6762960" cy="503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666800" y="1633680"/>
            <a:ext cx="5810400" cy="3133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1509840" y="274680"/>
            <a:ext cx="6124320" cy="585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12-06T02:39:36Z</dcterms:created>
  <dc:creator>Gunther Eysenbach</dc:creator>
  <dc:description/>
  <dc:language>en-US</dc:language>
  <cp:lastModifiedBy>Gunther Eysenbach</cp:lastModifiedBy>
  <dcterms:modified xsi:type="dcterms:W3CDTF">2002-12-06T02:51:20Z</dcterms:modified>
  <cp:revision>2</cp:revision>
  <dc:subject/>
  <dc:title>Slide 1</dc:title>
</cp:coreProperties>
</file>